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694"/>
  </p:normalViewPr>
  <p:slideViewPr>
    <p:cSldViewPr snapToGrid="0">
      <p:cViewPr varScale="1">
        <p:scale>
          <a:sx n="78" d="100"/>
          <a:sy n="78" d="100"/>
        </p:scale>
        <p:origin x="850"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08875D-497A-B668-2FC0-131838C6673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45F1E3E-8341-B8FA-A982-1F764FE9BFB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06CE42F-9581-868E-3C35-C319361EA486}"/>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5" name="Footer Placeholder 4">
            <a:extLst>
              <a:ext uri="{FF2B5EF4-FFF2-40B4-BE49-F238E27FC236}">
                <a16:creationId xmlns:a16="http://schemas.microsoft.com/office/drawing/2014/main" id="{C5627D70-3A2C-0100-70A1-892DAAB30D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E707CE-7424-25EA-E01B-BB630086C197}"/>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35199022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2B0409-4F05-02B4-D6E9-63047199997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826B363-6CD1-D448-D540-6E2698AFEB7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106CEB-DD48-E2B0-5B69-99A21609F533}"/>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5" name="Footer Placeholder 4">
            <a:extLst>
              <a:ext uri="{FF2B5EF4-FFF2-40B4-BE49-F238E27FC236}">
                <a16:creationId xmlns:a16="http://schemas.microsoft.com/office/drawing/2014/main" id="{99A46EAB-F96D-2383-F6D0-56A613DAAC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E64608C-A9E4-972D-83D3-CA023EA13B60}"/>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30495274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1D3BC15-56AD-F708-227E-909271AF10E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3D9A5B3-0FCA-FF1B-1F2F-D576512D13C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E46F34-7B0E-B548-7211-DFA740E1A842}"/>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5" name="Footer Placeholder 4">
            <a:extLst>
              <a:ext uri="{FF2B5EF4-FFF2-40B4-BE49-F238E27FC236}">
                <a16:creationId xmlns:a16="http://schemas.microsoft.com/office/drawing/2014/main" id="{885B29E9-F3ED-8A3B-3732-DA44838F6B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3C7ACDE-9CB3-EC3C-5041-8E22C56C5AFD}"/>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7817912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23A183-316B-6E21-9855-2E82ED35C00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69AC663-C933-D579-D8F3-EB5DCD17AA9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7709537-F66F-E27A-5D5E-0DA5B86EFB68}"/>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5" name="Footer Placeholder 4">
            <a:extLst>
              <a:ext uri="{FF2B5EF4-FFF2-40B4-BE49-F238E27FC236}">
                <a16:creationId xmlns:a16="http://schemas.microsoft.com/office/drawing/2014/main" id="{E4745FCF-361E-1ED4-047B-437DC499867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4A09FDC-0087-8456-8B0A-5466FD8F9654}"/>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41292326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E0FDB8-86C1-066B-0689-C9B0E294A6D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2A04B0C-78FA-E147-53B8-9803F55A786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F731043-03E6-2327-7B63-618F7DF2EB44}"/>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5" name="Footer Placeholder 4">
            <a:extLst>
              <a:ext uri="{FF2B5EF4-FFF2-40B4-BE49-F238E27FC236}">
                <a16:creationId xmlns:a16="http://schemas.microsoft.com/office/drawing/2014/main" id="{E3A5A5B8-D726-1D3C-8A94-D2FA21D5DD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5B4DB9-A5CE-6466-BF9F-D641CC0BC124}"/>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8441241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5C6060-7A6E-C182-91E5-D43349DBA3F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E071BD4-A092-CA3E-9D62-4A6D29F22E5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21BB7C8-F906-EA56-E4D6-76BB4AC5F4F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6F08EF6-2FEB-43BF-818E-36789C66BFED}"/>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6" name="Footer Placeholder 5">
            <a:extLst>
              <a:ext uri="{FF2B5EF4-FFF2-40B4-BE49-F238E27FC236}">
                <a16:creationId xmlns:a16="http://schemas.microsoft.com/office/drawing/2014/main" id="{8898EF25-F4BB-E94C-90CF-11791565DE2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8724D4-C3A9-8C90-F0E7-B4ACDD87D8E4}"/>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30780498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8E78B3-41FC-5C00-8CD0-B91F5A5B569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DC00F7B-C7C6-9870-382B-46FD75AB820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99227D3-751A-D8F7-43B8-04F96596412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2378344-FB6A-61BD-CEF3-4D83D98DCB0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34C396B-9FA0-1685-FBB4-2AE8ACAA861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8E99185-7049-E0D0-08D2-1AC7E12F4406}"/>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8" name="Footer Placeholder 7">
            <a:extLst>
              <a:ext uri="{FF2B5EF4-FFF2-40B4-BE49-F238E27FC236}">
                <a16:creationId xmlns:a16="http://schemas.microsoft.com/office/drawing/2014/main" id="{8967A381-1561-98C2-94C4-F4D126BE380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A906145-8993-0A4C-1189-DCE7D073CFF7}"/>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11142114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DD3A2C-E075-A138-DE5E-D3CA4847E37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6609685-D7A4-D5E1-08C6-7978B5ED9EC8}"/>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4" name="Footer Placeholder 3">
            <a:extLst>
              <a:ext uri="{FF2B5EF4-FFF2-40B4-BE49-F238E27FC236}">
                <a16:creationId xmlns:a16="http://schemas.microsoft.com/office/drawing/2014/main" id="{26F80A58-7120-C923-F76C-8A675A3F5F3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57FFB5E-3974-ACB7-57E5-0EDA6045BD59}"/>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36070634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F4BAA25-F3C6-08CF-8E76-BDA4ABCFABAE}"/>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3" name="Footer Placeholder 2">
            <a:extLst>
              <a:ext uri="{FF2B5EF4-FFF2-40B4-BE49-F238E27FC236}">
                <a16:creationId xmlns:a16="http://schemas.microsoft.com/office/drawing/2014/main" id="{A0378E69-4D05-04CA-3D16-DC1D4D2537A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8A4E0BE-83E0-1314-5861-A7F138D18A2B}"/>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38424767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902A18-66B4-74CB-5D88-22F808A77A0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06C617A-861D-A179-26EB-E955F8270AC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3BE0068-A439-11CE-FD9C-3C02AE0696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8A8DB1-236E-F6EC-8758-9DA4D60BF4BF}"/>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6" name="Footer Placeholder 5">
            <a:extLst>
              <a:ext uri="{FF2B5EF4-FFF2-40B4-BE49-F238E27FC236}">
                <a16:creationId xmlns:a16="http://schemas.microsoft.com/office/drawing/2014/main" id="{565BCBF1-BFCE-9482-0CCF-DC0BE4A35A0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C5743E-C74C-8531-172A-561C16923EE4}"/>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21676626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3F1A47-2B0A-AD5B-9F9A-A7EF7A4808C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8C98E6-D394-68E6-1A76-7A3C711B12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6463A46-8155-E451-A847-F207B766506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273AE45-C88A-A805-B1FA-E41ED1BC02AC}"/>
              </a:ext>
            </a:extLst>
          </p:cNvPr>
          <p:cNvSpPr>
            <a:spLocks noGrp="1"/>
          </p:cNvSpPr>
          <p:nvPr>
            <p:ph type="dt" sz="half" idx="10"/>
          </p:nvPr>
        </p:nvSpPr>
        <p:spPr/>
        <p:txBody>
          <a:bodyPr/>
          <a:lstStyle/>
          <a:p>
            <a:fld id="{A78A6CDC-7057-084A-9CD6-7E3A3B3652F5}" type="datetimeFigureOut">
              <a:rPr lang="en-US" smtClean="0"/>
              <a:t>2025-10-17</a:t>
            </a:fld>
            <a:endParaRPr lang="en-US"/>
          </a:p>
        </p:txBody>
      </p:sp>
      <p:sp>
        <p:nvSpPr>
          <p:cNvPr id="6" name="Footer Placeholder 5">
            <a:extLst>
              <a:ext uri="{FF2B5EF4-FFF2-40B4-BE49-F238E27FC236}">
                <a16:creationId xmlns:a16="http://schemas.microsoft.com/office/drawing/2014/main" id="{87D586BF-1091-6C8E-C65C-3CFE9FA5A5A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ACEA4CC-B613-E3AE-931E-C7B0EFBD5155}"/>
              </a:ext>
            </a:extLst>
          </p:cNvPr>
          <p:cNvSpPr>
            <a:spLocks noGrp="1"/>
          </p:cNvSpPr>
          <p:nvPr>
            <p:ph type="sldNum" sz="quarter" idx="12"/>
          </p:nvPr>
        </p:nvSpPr>
        <p:spPr/>
        <p:txBody>
          <a:bodyPr/>
          <a:lstStyle/>
          <a:p>
            <a:fld id="{F43FE2EE-A3D7-E74E-9DC5-49B5B9197D80}" type="slidenum">
              <a:rPr lang="en-US" smtClean="0"/>
              <a:t>‹#›</a:t>
            </a:fld>
            <a:endParaRPr lang="en-US"/>
          </a:p>
        </p:txBody>
      </p:sp>
    </p:spTree>
    <p:extLst>
      <p:ext uri="{BB962C8B-B14F-4D97-AF65-F5344CB8AC3E}">
        <p14:creationId xmlns:p14="http://schemas.microsoft.com/office/powerpoint/2010/main" val="24036975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B3EACB8-B934-48DA-4CA2-43A1B2A498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3A499C5-3329-2CAD-E1C4-64434DD36CE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C4B79A6-133F-8287-29FD-9C9A39BC91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78A6CDC-7057-084A-9CD6-7E3A3B3652F5}" type="datetimeFigureOut">
              <a:rPr lang="en-US" smtClean="0"/>
              <a:t>2025-10-17</a:t>
            </a:fld>
            <a:endParaRPr lang="en-US"/>
          </a:p>
        </p:txBody>
      </p:sp>
      <p:sp>
        <p:nvSpPr>
          <p:cNvPr id="5" name="Footer Placeholder 4">
            <a:extLst>
              <a:ext uri="{FF2B5EF4-FFF2-40B4-BE49-F238E27FC236}">
                <a16:creationId xmlns:a16="http://schemas.microsoft.com/office/drawing/2014/main" id="{52F74E09-EEB6-FC47-B205-5BB5888072B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EBBEF5EE-541B-C63F-7B15-EE36D45E1DE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43FE2EE-A3D7-E74E-9DC5-49B5B9197D80}" type="slidenum">
              <a:rPr lang="en-US" smtClean="0"/>
              <a:t>‹#›</a:t>
            </a:fld>
            <a:endParaRPr lang="en-US"/>
          </a:p>
        </p:txBody>
      </p:sp>
    </p:spTree>
    <p:extLst>
      <p:ext uri="{BB962C8B-B14F-4D97-AF65-F5344CB8AC3E}">
        <p14:creationId xmlns:p14="http://schemas.microsoft.com/office/powerpoint/2010/main" val="22052059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486D71A-1BF7-6EED-1066-4ED8ECEA1DD3}"/>
              </a:ext>
            </a:extLst>
          </p:cNvPr>
          <p:cNvPicPr>
            <a:picLocks noChangeAspect="1"/>
          </p:cNvPicPr>
          <p:nvPr/>
        </p:nvPicPr>
        <p:blipFill>
          <a:blip r:embed="rId2"/>
          <a:stretch>
            <a:fillRect/>
          </a:stretch>
        </p:blipFill>
        <p:spPr>
          <a:xfrm>
            <a:off x="2102069" y="374994"/>
            <a:ext cx="7772400" cy="3331028"/>
          </a:xfrm>
          <a:prstGeom prst="rect">
            <a:avLst/>
          </a:prstGeom>
        </p:spPr>
      </p:pic>
      <p:sp>
        <p:nvSpPr>
          <p:cNvPr id="6" name="TextBox 5">
            <a:extLst>
              <a:ext uri="{FF2B5EF4-FFF2-40B4-BE49-F238E27FC236}">
                <a16:creationId xmlns:a16="http://schemas.microsoft.com/office/drawing/2014/main" id="{10992DFD-EE8A-9911-B35F-97ED73CA23ED}"/>
              </a:ext>
            </a:extLst>
          </p:cNvPr>
          <p:cNvSpPr txBox="1"/>
          <p:nvPr/>
        </p:nvSpPr>
        <p:spPr>
          <a:xfrm>
            <a:off x="1232337" y="4088523"/>
            <a:ext cx="9511864" cy="507831"/>
          </a:xfrm>
          <a:prstGeom prst="rect">
            <a:avLst/>
          </a:prstGeom>
          <a:noFill/>
        </p:spPr>
        <p:txBody>
          <a:bodyPr wrap="square" rtlCol="0">
            <a:spAutoFit/>
          </a:bodyPr>
          <a:lstStyle/>
          <a:p>
            <a:r>
              <a:rPr lang="en-US" sz="900" b="1"/>
              <a:t>Figure </a:t>
            </a:r>
            <a:r>
              <a:rPr lang="en-US" sz="900" b="1" dirty="0"/>
              <a:t>S4.</a:t>
            </a:r>
            <a:r>
              <a:rPr lang="en-US" sz="900" dirty="0"/>
              <a:t> Alpha diversity metrics of Actinobacteria communities across host organisms. Bar plots illustrate (A) Observed ASV richness (exact numbers given above bars), (B) Shannon diversity index, and (C) Simpson diversity index for each sample.</a:t>
            </a:r>
          </a:p>
          <a:p>
            <a:endParaRPr lang="en-US" sz="900" dirty="0"/>
          </a:p>
        </p:txBody>
      </p:sp>
    </p:spTree>
    <p:extLst>
      <p:ext uri="{BB962C8B-B14F-4D97-AF65-F5344CB8AC3E}">
        <p14:creationId xmlns:p14="http://schemas.microsoft.com/office/powerpoint/2010/main" val="34998272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TotalTime>
  <Words>47</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osea Masaki</dc:creator>
  <cp:lastModifiedBy>MDPI</cp:lastModifiedBy>
  <cp:revision>2</cp:revision>
  <dcterms:created xsi:type="dcterms:W3CDTF">2025-09-25T11:24:56Z</dcterms:created>
  <dcterms:modified xsi:type="dcterms:W3CDTF">2025-10-17T14:34:55Z</dcterms:modified>
</cp:coreProperties>
</file>